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9" autoAdjust="0"/>
    <p:restoredTop sz="94660"/>
  </p:normalViewPr>
  <p:slideViewPr>
    <p:cSldViewPr snapToGrid="0">
      <p:cViewPr varScale="1">
        <p:scale>
          <a:sx n="74" d="100"/>
          <a:sy n="74" d="100"/>
        </p:scale>
        <p:origin x="3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DA4B5-338B-422A-9880-FF021735663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CF5C3-F7E5-46CC-9228-BFA9283D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725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DA4B5-338B-422A-9880-FF021735663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CF5C3-F7E5-46CC-9228-BFA9283D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56867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DA4B5-338B-422A-9880-FF021735663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CF5C3-F7E5-46CC-9228-BFA9283D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732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DA4B5-338B-422A-9880-FF021735663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CF5C3-F7E5-46CC-9228-BFA9283D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89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DA4B5-338B-422A-9880-FF021735663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CF5C3-F7E5-46CC-9228-BFA9283D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732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DA4B5-338B-422A-9880-FF021735663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CF5C3-F7E5-46CC-9228-BFA9283D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544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DA4B5-338B-422A-9880-FF021735663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CF5C3-F7E5-46CC-9228-BFA9283D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464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DA4B5-338B-422A-9880-FF021735663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CF5C3-F7E5-46CC-9228-BFA9283D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419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DA4B5-338B-422A-9880-FF021735663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CF5C3-F7E5-46CC-9228-BFA9283D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144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DA4B5-338B-422A-9880-FF021735663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CF5C3-F7E5-46CC-9228-BFA9283D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746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DA4B5-338B-422A-9880-FF021735663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CF5C3-F7E5-46CC-9228-BFA9283D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133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FDA4B5-338B-422A-9880-FF021735663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5CF5C3-F7E5-46CC-9228-BFA9283D7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502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8294" y="501370"/>
            <a:ext cx="6096000" cy="382905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156"/>
          <a:stretch/>
        </p:blipFill>
        <p:spPr>
          <a:xfrm>
            <a:off x="2923056" y="4533547"/>
            <a:ext cx="6096000" cy="14119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05915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B2B147EE-77DB-47A7-BEB0-3C6E6B92CB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79157" y="1477628"/>
            <a:ext cx="4433685" cy="3902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64715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91673" y="669701"/>
            <a:ext cx="10827131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 smtClean="0"/>
              <a:t>Figure S2.</a:t>
            </a:r>
            <a:r>
              <a:rPr lang="en-US" b="1" u="sng" dirty="0"/>
              <a:t> </a:t>
            </a:r>
            <a:r>
              <a:rPr lang="en-US" b="1" dirty="0"/>
              <a:t>Testing </a:t>
            </a:r>
            <a:r>
              <a:rPr lang="en-US" b="1" dirty="0" err="1"/>
              <a:t>tagmentation</a:t>
            </a:r>
            <a:r>
              <a:rPr lang="en-US" b="1" dirty="0"/>
              <a:t> efficiency on circular DNA substrates of different length. </a:t>
            </a:r>
            <a:endParaRPr lang="en-US" b="1" dirty="0" smtClean="0"/>
          </a:p>
          <a:p>
            <a:r>
              <a:rPr lang="en-US" dirty="0" smtClean="0"/>
              <a:t>A </a:t>
            </a:r>
            <a:r>
              <a:rPr lang="en-US" dirty="0"/>
              <a:t>3-kbp plasmid DNA (derived from pGEM5Zf+) and 412-bp circular DNA molecules were fragmented using </a:t>
            </a:r>
            <a:endParaRPr lang="en-US" dirty="0" smtClean="0"/>
          </a:p>
          <a:p>
            <a:r>
              <a:rPr lang="en-US" dirty="0" err="1" smtClean="0"/>
              <a:t>Nextera</a:t>
            </a:r>
            <a:r>
              <a:rPr lang="en-US" dirty="0" smtClean="0"/>
              <a:t>-XT </a:t>
            </a:r>
            <a:r>
              <a:rPr lang="en-US" dirty="0" err="1"/>
              <a:t>tagmentase</a:t>
            </a:r>
            <a:r>
              <a:rPr lang="en-US" dirty="0"/>
              <a:t>.  This graph provides a position-by-position summary of aligned reads.  The orange arrow </a:t>
            </a:r>
            <a:endParaRPr lang="en-US" dirty="0" smtClean="0"/>
          </a:p>
          <a:p>
            <a:r>
              <a:rPr lang="en-US" dirty="0" smtClean="0"/>
              <a:t>indicates </a:t>
            </a:r>
            <a:r>
              <a:rPr lang="en-US" dirty="0"/>
              <a:t>a read length of a singly-</a:t>
            </a:r>
            <a:r>
              <a:rPr lang="en-US" dirty="0" err="1"/>
              <a:t>tagmented</a:t>
            </a:r>
            <a:r>
              <a:rPr lang="en-US" dirty="0"/>
              <a:t> circle, 421 </a:t>
            </a:r>
            <a:r>
              <a:rPr lang="en-US" dirty="0" err="1"/>
              <a:t>bp</a:t>
            </a:r>
            <a:r>
              <a:rPr lang="en-US" dirty="0"/>
              <a:t> (412 </a:t>
            </a:r>
            <a:r>
              <a:rPr lang="en-US" dirty="0" err="1"/>
              <a:t>bp</a:t>
            </a:r>
            <a:r>
              <a:rPr lang="en-US" dirty="0"/>
              <a:t> + 9 </a:t>
            </a:r>
            <a:r>
              <a:rPr lang="en-US" dirty="0" err="1"/>
              <a:t>bp</a:t>
            </a:r>
            <a:r>
              <a:rPr lang="en-US" dirty="0"/>
              <a:t> duplication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7145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3</Words>
  <Application>Microsoft Office PowerPoint</Application>
  <PresentationFormat>Widescreen</PresentationFormat>
  <Paragraphs>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ssa Shoura</dc:creator>
  <cp:lastModifiedBy>Sarah Wolper</cp:lastModifiedBy>
  <cp:revision>4</cp:revision>
  <dcterms:created xsi:type="dcterms:W3CDTF">2016-12-16T15:31:38Z</dcterms:created>
  <dcterms:modified xsi:type="dcterms:W3CDTF">2017-08-11T11:20:40Z</dcterms:modified>
</cp:coreProperties>
</file>